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notesMasterIdLst>
    <p:notesMasterId r:id="rId3"/>
  </p:notesMasterIdLst>
  <p:sldIdLst>
    <p:sldId id="264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029" autoAdjust="0"/>
    <p:restoredTop sz="94660"/>
  </p:normalViewPr>
  <p:slideViewPr>
    <p:cSldViewPr snapToGrid="0">
      <p:cViewPr>
        <p:scale>
          <a:sx n="100" d="100"/>
          <a:sy n="100" d="100"/>
        </p:scale>
        <p:origin x="1218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1564B2D-10F1-4B16-800E-476A256DD7D4}" type="datetimeFigureOut">
              <a:rPr lang="en-US" smtClean="0"/>
              <a:t>12/11/2021</a:t>
            </a:fld>
            <a:endParaRPr lang="en-US" dirty="0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 dirty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ABF210F-1C06-45C4-89EB-4B817AF7A90F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07389585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C11504-CD2F-46C0-8827-3B52FE3886B6}" type="datetimeFigureOut">
              <a:rPr lang="en-US" smtClean="0"/>
              <a:t>12/11/2021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060997-F546-4B3D-B833-5CCB90CBBB59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84941993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C11504-CD2F-46C0-8827-3B52FE3886B6}" type="datetimeFigureOut">
              <a:rPr lang="en-US" smtClean="0"/>
              <a:t>12/11/2021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060997-F546-4B3D-B833-5CCB90CBBB59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55903045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C11504-CD2F-46C0-8827-3B52FE3886B6}" type="datetimeFigureOut">
              <a:rPr lang="en-US" smtClean="0"/>
              <a:t>12/11/2021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060997-F546-4B3D-B833-5CCB90CBBB59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86596509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C11504-CD2F-46C0-8827-3B52FE3886B6}" type="datetimeFigureOut">
              <a:rPr lang="en-US" smtClean="0"/>
              <a:t>12/11/2021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060997-F546-4B3D-B833-5CCB90CBBB59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23102215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C11504-CD2F-46C0-8827-3B52FE3886B6}" type="datetimeFigureOut">
              <a:rPr lang="en-US" smtClean="0"/>
              <a:t>12/11/2021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060997-F546-4B3D-B833-5CCB90CBBB59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96674309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C11504-CD2F-46C0-8827-3B52FE3886B6}" type="datetimeFigureOut">
              <a:rPr lang="en-US" smtClean="0"/>
              <a:t>12/11/2021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060997-F546-4B3D-B833-5CCB90CBBB59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36742747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C11504-CD2F-46C0-8827-3B52FE3886B6}" type="datetimeFigureOut">
              <a:rPr lang="en-US" smtClean="0"/>
              <a:t>12/11/2021</a:t>
            </a:fld>
            <a:endParaRPr lang="en-US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060997-F546-4B3D-B833-5CCB90CBBB59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95612389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C11504-CD2F-46C0-8827-3B52FE3886B6}" type="datetimeFigureOut">
              <a:rPr lang="en-US" smtClean="0"/>
              <a:t>12/11/2021</a:t>
            </a:fld>
            <a:endParaRPr lang="en-US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060997-F546-4B3D-B833-5CCB90CBBB59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7019311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C11504-CD2F-46C0-8827-3B52FE3886B6}" type="datetimeFigureOut">
              <a:rPr lang="en-US" smtClean="0"/>
              <a:t>12/11/2021</a:t>
            </a:fld>
            <a:endParaRPr 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060997-F546-4B3D-B833-5CCB90CBBB59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34421297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C11504-CD2F-46C0-8827-3B52FE3886B6}" type="datetimeFigureOut">
              <a:rPr lang="en-US" smtClean="0"/>
              <a:t>12/11/2021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060997-F546-4B3D-B833-5CCB90CBBB59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83197601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dirty="0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C11504-CD2F-46C0-8827-3B52FE3886B6}" type="datetimeFigureOut">
              <a:rPr lang="en-US" smtClean="0"/>
              <a:t>12/11/2021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060997-F546-4B3D-B833-5CCB90CBBB59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07922039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0C11504-CD2F-46C0-8827-3B52FE3886B6}" type="datetimeFigureOut">
              <a:rPr lang="en-US" smtClean="0"/>
              <a:t>12/11/2021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4060997-F546-4B3D-B833-5CCB90CBBB59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70638789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891" t="11675" r="1126" b="22563"/>
          <a:stretch/>
        </p:blipFill>
        <p:spPr>
          <a:xfrm>
            <a:off x="1352550" y="1176267"/>
            <a:ext cx="4705350" cy="2201933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755650" y="1130301"/>
            <a:ext cx="257658" cy="2540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1000" b="1" dirty="0">
                <a:solidFill>
                  <a:schemeClr val="dk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sz="1000" b="1" dirty="0">
              <a:solidFill>
                <a:schemeClr val="dk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TextBox 3"/>
          <p:cNvSpPr txBox="1"/>
          <p:nvPr/>
        </p:nvSpPr>
        <p:spPr>
          <a:xfrm>
            <a:off x="923925" y="2520951"/>
            <a:ext cx="61960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800" b="1" dirty="0">
                <a:solidFill>
                  <a:schemeClr val="dk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500bp</a:t>
            </a:r>
            <a:endParaRPr lang="en-US" sz="800" b="1" dirty="0">
              <a:solidFill>
                <a:schemeClr val="dk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TextBox 4"/>
          <p:cNvSpPr txBox="1"/>
          <p:nvPr/>
        </p:nvSpPr>
        <p:spPr>
          <a:xfrm>
            <a:off x="1042746" y="2356307"/>
            <a:ext cx="61960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800" b="1" dirty="0">
                <a:solidFill>
                  <a:schemeClr val="dk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kb</a:t>
            </a:r>
            <a:endParaRPr lang="en-US" sz="800" b="1" dirty="0">
              <a:solidFill>
                <a:schemeClr val="dk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1779830" y="3061610"/>
            <a:ext cx="46807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8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#5-1</a:t>
            </a:r>
            <a:endParaRPr lang="en-US" sz="8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2131772" y="3061610"/>
            <a:ext cx="46807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8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5-2</a:t>
            </a:r>
            <a:endParaRPr lang="en-US" sz="8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2477364" y="3061610"/>
            <a:ext cx="46807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8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5-3</a:t>
            </a:r>
            <a:endParaRPr lang="en-US" sz="8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2781732" y="3061610"/>
            <a:ext cx="46807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8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5-4</a:t>
            </a:r>
            <a:endParaRPr lang="en-US" sz="8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3083788" y="3061610"/>
            <a:ext cx="46807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8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5-5</a:t>
            </a:r>
            <a:endParaRPr lang="en-US" sz="8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3380892" y="3061610"/>
            <a:ext cx="46807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8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5-6</a:t>
            </a:r>
            <a:endParaRPr lang="en-US" sz="8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xtBox 12"/>
          <p:cNvSpPr txBox="1"/>
          <p:nvPr/>
        </p:nvSpPr>
        <p:spPr>
          <a:xfrm>
            <a:off x="3906165" y="3061610"/>
            <a:ext cx="46807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8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#13-1</a:t>
            </a:r>
            <a:endParaRPr lang="en-US" sz="8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TextBox 13"/>
          <p:cNvSpPr txBox="1"/>
          <p:nvPr/>
        </p:nvSpPr>
        <p:spPr>
          <a:xfrm>
            <a:off x="4246079" y="3061610"/>
            <a:ext cx="46807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8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3-2</a:t>
            </a:r>
            <a:endParaRPr lang="en-US" sz="8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TextBox 14"/>
          <p:cNvSpPr txBox="1"/>
          <p:nvPr/>
        </p:nvSpPr>
        <p:spPr>
          <a:xfrm>
            <a:off x="4572621" y="3061610"/>
            <a:ext cx="46807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8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3-3</a:t>
            </a:r>
            <a:endParaRPr lang="en-US" sz="8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TextBox 15"/>
          <p:cNvSpPr txBox="1"/>
          <p:nvPr/>
        </p:nvSpPr>
        <p:spPr>
          <a:xfrm>
            <a:off x="4888775" y="3061610"/>
            <a:ext cx="46807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8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3-4</a:t>
            </a:r>
            <a:endParaRPr lang="en-US" sz="8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TextBox 16"/>
          <p:cNvSpPr txBox="1"/>
          <p:nvPr/>
        </p:nvSpPr>
        <p:spPr>
          <a:xfrm>
            <a:off x="5225946" y="3061610"/>
            <a:ext cx="46807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8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3-5</a:t>
            </a:r>
            <a:endParaRPr lang="en-US" sz="8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8" name="Picture 17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036" t="17781" r="988" b="20310"/>
          <a:stretch/>
        </p:blipFill>
        <p:spPr>
          <a:xfrm>
            <a:off x="1350237" y="3651250"/>
            <a:ext cx="4707663" cy="2330450"/>
          </a:xfrm>
          <a:prstGeom prst="rect">
            <a:avLst/>
          </a:prstGeom>
        </p:spPr>
      </p:pic>
      <p:sp>
        <p:nvSpPr>
          <p:cNvPr id="19" name="TextBox 18"/>
          <p:cNvSpPr txBox="1"/>
          <p:nvPr/>
        </p:nvSpPr>
        <p:spPr>
          <a:xfrm>
            <a:off x="1494080" y="3061610"/>
            <a:ext cx="22854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8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  <a:endParaRPr lang="en-US" sz="8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TextBox 19"/>
          <p:cNvSpPr txBox="1"/>
          <p:nvPr/>
        </p:nvSpPr>
        <p:spPr>
          <a:xfrm>
            <a:off x="5623976" y="3061610"/>
            <a:ext cx="22854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8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  <a:endParaRPr lang="en-US" sz="8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TextBox 20"/>
          <p:cNvSpPr txBox="1"/>
          <p:nvPr/>
        </p:nvSpPr>
        <p:spPr>
          <a:xfrm>
            <a:off x="964232" y="2210713"/>
            <a:ext cx="61960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800" b="1" dirty="0">
                <a:solidFill>
                  <a:schemeClr val="dk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.5kb</a:t>
            </a:r>
            <a:endParaRPr lang="en-US" sz="800" b="1" dirty="0">
              <a:solidFill>
                <a:schemeClr val="dk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TextBox 21"/>
          <p:cNvSpPr txBox="1"/>
          <p:nvPr/>
        </p:nvSpPr>
        <p:spPr>
          <a:xfrm>
            <a:off x="1779830" y="5544460"/>
            <a:ext cx="46807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8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#5-1</a:t>
            </a:r>
            <a:endParaRPr lang="en-US" sz="8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TextBox 22"/>
          <p:cNvSpPr txBox="1"/>
          <p:nvPr/>
        </p:nvSpPr>
        <p:spPr>
          <a:xfrm>
            <a:off x="2100022" y="5544460"/>
            <a:ext cx="46807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8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5-2</a:t>
            </a:r>
            <a:endParaRPr lang="en-US" sz="8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TextBox 23"/>
          <p:cNvSpPr txBox="1"/>
          <p:nvPr/>
        </p:nvSpPr>
        <p:spPr>
          <a:xfrm>
            <a:off x="2445614" y="5544460"/>
            <a:ext cx="46807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8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5-3</a:t>
            </a:r>
            <a:endParaRPr lang="en-US" sz="8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2749982" y="5544460"/>
            <a:ext cx="46807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8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5-4</a:t>
            </a:r>
            <a:endParaRPr lang="en-US" sz="8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TextBox 25"/>
          <p:cNvSpPr txBox="1"/>
          <p:nvPr/>
        </p:nvSpPr>
        <p:spPr>
          <a:xfrm>
            <a:off x="3077438" y="5544460"/>
            <a:ext cx="46807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8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5-5</a:t>
            </a:r>
            <a:endParaRPr lang="en-US" sz="8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TextBox 26"/>
          <p:cNvSpPr txBox="1"/>
          <p:nvPr/>
        </p:nvSpPr>
        <p:spPr>
          <a:xfrm>
            <a:off x="3361842" y="5544460"/>
            <a:ext cx="46807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8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5-6</a:t>
            </a:r>
            <a:endParaRPr lang="en-US" sz="8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3976015" y="5544460"/>
            <a:ext cx="46807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8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#13-1</a:t>
            </a:r>
            <a:endParaRPr lang="en-US" sz="8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TextBox 28"/>
          <p:cNvSpPr txBox="1"/>
          <p:nvPr/>
        </p:nvSpPr>
        <p:spPr>
          <a:xfrm>
            <a:off x="4315929" y="5544460"/>
            <a:ext cx="46807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8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3-2</a:t>
            </a:r>
            <a:endParaRPr lang="en-US" sz="8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TextBox 29"/>
          <p:cNvSpPr txBox="1"/>
          <p:nvPr/>
        </p:nvSpPr>
        <p:spPr>
          <a:xfrm>
            <a:off x="4617071" y="5544460"/>
            <a:ext cx="46807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8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3-3</a:t>
            </a:r>
            <a:endParaRPr lang="en-US" sz="8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TextBox 30"/>
          <p:cNvSpPr txBox="1"/>
          <p:nvPr/>
        </p:nvSpPr>
        <p:spPr>
          <a:xfrm>
            <a:off x="4939575" y="5544460"/>
            <a:ext cx="46807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8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3-4</a:t>
            </a:r>
            <a:endParaRPr lang="en-US" sz="8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TextBox 31"/>
          <p:cNvSpPr txBox="1"/>
          <p:nvPr/>
        </p:nvSpPr>
        <p:spPr>
          <a:xfrm>
            <a:off x="5270396" y="5544460"/>
            <a:ext cx="46807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8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3-5</a:t>
            </a:r>
            <a:endParaRPr lang="en-US" sz="8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TextBox 32"/>
          <p:cNvSpPr txBox="1"/>
          <p:nvPr/>
        </p:nvSpPr>
        <p:spPr>
          <a:xfrm>
            <a:off x="1468680" y="5544460"/>
            <a:ext cx="22854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8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  <a:endParaRPr lang="en-US" sz="8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TextBox 33"/>
          <p:cNvSpPr txBox="1"/>
          <p:nvPr/>
        </p:nvSpPr>
        <p:spPr>
          <a:xfrm>
            <a:off x="3730762" y="5544460"/>
            <a:ext cx="22854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8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  <a:endParaRPr lang="en-US" sz="8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TextBox 34"/>
          <p:cNvSpPr txBox="1"/>
          <p:nvPr/>
        </p:nvSpPr>
        <p:spPr>
          <a:xfrm>
            <a:off x="1053132" y="4786092"/>
            <a:ext cx="61960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800" b="1" dirty="0">
                <a:solidFill>
                  <a:schemeClr val="dk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kb</a:t>
            </a:r>
            <a:endParaRPr lang="en-US" sz="800" b="1" dirty="0">
              <a:solidFill>
                <a:schemeClr val="dk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TextBox 35"/>
          <p:cNvSpPr txBox="1"/>
          <p:nvPr/>
        </p:nvSpPr>
        <p:spPr>
          <a:xfrm>
            <a:off x="974618" y="4640498"/>
            <a:ext cx="61960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800" b="1" dirty="0">
                <a:solidFill>
                  <a:schemeClr val="dk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.5kb</a:t>
            </a:r>
            <a:endParaRPr lang="en-US" sz="800" b="1" dirty="0">
              <a:solidFill>
                <a:schemeClr val="dk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TextBox 36"/>
          <p:cNvSpPr txBox="1"/>
          <p:nvPr/>
        </p:nvSpPr>
        <p:spPr>
          <a:xfrm>
            <a:off x="963346" y="4954820"/>
            <a:ext cx="61960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800" b="1" dirty="0">
                <a:solidFill>
                  <a:schemeClr val="dk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500bp</a:t>
            </a:r>
            <a:endParaRPr lang="en-US" sz="800" b="1" dirty="0">
              <a:solidFill>
                <a:schemeClr val="dk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TextBox 37"/>
          <p:cNvSpPr txBox="1"/>
          <p:nvPr/>
        </p:nvSpPr>
        <p:spPr>
          <a:xfrm>
            <a:off x="755650" y="3651250"/>
            <a:ext cx="257658" cy="2540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1000" b="1" dirty="0">
                <a:solidFill>
                  <a:schemeClr val="dk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US" sz="1000" b="1" dirty="0">
              <a:solidFill>
                <a:schemeClr val="dk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TextBox 38"/>
          <p:cNvSpPr txBox="1"/>
          <p:nvPr/>
        </p:nvSpPr>
        <p:spPr>
          <a:xfrm>
            <a:off x="1051408" y="6343753"/>
            <a:ext cx="5263566" cy="76944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CA" sz="1100" b="1" dirty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CA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3.</a:t>
            </a:r>
            <a:r>
              <a:rPr lang="en-CA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CA" sz="1100" dirty="0">
                <a:latin typeface="Arial" panose="020B0604020202020204" pitchFamily="34" charset="0"/>
                <a:cs typeface="Arial" panose="020B0604020202020204" pitchFamily="34" charset="0"/>
              </a:rPr>
              <a:t>Example agarose gels showing detection of </a:t>
            </a:r>
            <a:r>
              <a:rPr lang="en-CA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transgene </a:t>
            </a:r>
            <a:r>
              <a:rPr lang="en-CA" sz="1100" dirty="0">
                <a:latin typeface="Arial" panose="020B0604020202020204" pitchFamily="34" charset="0"/>
                <a:cs typeface="Arial" panose="020B0604020202020204" pitchFamily="34" charset="0"/>
              </a:rPr>
              <a:t>in GmPDS8 T1 plants. (A) PCR amplification of a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885-bp fragment containing AtU6 promoter, sgRNA, U6 terminator, and part of pEG301 backbone. </a:t>
            </a:r>
            <a:r>
              <a:rPr lang="en-CA" sz="1100" dirty="0">
                <a:latin typeface="Arial" panose="020B0604020202020204" pitchFamily="34" charset="0"/>
                <a:cs typeface="Arial" panose="020B0604020202020204" pitchFamily="34" charset="0"/>
              </a:rPr>
              <a:t>(B) PCR amplification of a 1117-bp fragment containing part of Cas9 and eGFP. M - DNA ladder.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06376451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1</TotalTime>
  <Words>98</Words>
  <Application>Microsoft Office PowerPoint</Application>
  <PresentationFormat>A4 Paper (210x297 mm)</PresentationFormat>
  <Paragraphs>3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u, Mimmie</dc:creator>
  <cp:lastModifiedBy>Lu, Mimmie</cp:lastModifiedBy>
  <cp:revision>20</cp:revision>
  <dcterms:created xsi:type="dcterms:W3CDTF">2021-07-22T20:59:52Z</dcterms:created>
  <dcterms:modified xsi:type="dcterms:W3CDTF">2021-12-11T20:07:56Z</dcterms:modified>
</cp:coreProperties>
</file>